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8" r:id="rId2"/>
    <p:sldId id="274" r:id="rId3"/>
    <p:sldId id="277" r:id="rId4"/>
  </p:sldIdLst>
  <p:sldSz cx="73152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9" autoAdjust="0"/>
    <p:restoredTop sz="94660"/>
  </p:normalViewPr>
  <p:slideViewPr>
    <p:cSldViewPr snapToGrid="0">
      <p:cViewPr varScale="1">
        <p:scale>
          <a:sx n="78" d="100"/>
          <a:sy n="78" d="100"/>
        </p:scale>
        <p:origin x="300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646133"/>
            <a:ext cx="6217920" cy="3501813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5282989"/>
            <a:ext cx="5486400" cy="2428451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7803CA-EE5D-4B1E-AE20-CD5DD2CACD76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C3E8C-B9E3-453C-8C69-77085BD04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70012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7803CA-EE5D-4B1E-AE20-CD5DD2CACD76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C3E8C-B9E3-453C-8C69-77085BD04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79160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535517"/>
            <a:ext cx="1577340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535517"/>
            <a:ext cx="4640580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7803CA-EE5D-4B1E-AE20-CD5DD2CACD76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C3E8C-B9E3-453C-8C69-77085BD04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92329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7803CA-EE5D-4B1E-AE20-CD5DD2CACD76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C3E8C-B9E3-453C-8C69-77085BD04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01226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2507618"/>
            <a:ext cx="6309360" cy="4184014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6731215"/>
            <a:ext cx="6309360" cy="2200274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7803CA-EE5D-4B1E-AE20-CD5DD2CACD76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C3E8C-B9E3-453C-8C69-77085BD04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64759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2677584"/>
            <a:ext cx="310896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2677584"/>
            <a:ext cx="310896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7803CA-EE5D-4B1E-AE20-CD5DD2CACD76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C3E8C-B9E3-453C-8C69-77085BD04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26553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535519"/>
            <a:ext cx="6309360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2465706"/>
            <a:ext cx="3094672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3674110"/>
            <a:ext cx="309467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2465706"/>
            <a:ext cx="3109913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3674110"/>
            <a:ext cx="3109913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7803CA-EE5D-4B1E-AE20-CD5DD2CACD76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C3E8C-B9E3-453C-8C69-77085BD04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76797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7803CA-EE5D-4B1E-AE20-CD5DD2CACD76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C3E8C-B9E3-453C-8C69-77085BD04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6686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7803CA-EE5D-4B1E-AE20-CD5DD2CACD76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C3E8C-B9E3-453C-8C69-77085BD04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97311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448226"/>
            <a:ext cx="3703320" cy="7147983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7803CA-EE5D-4B1E-AE20-CD5DD2CACD76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C3E8C-B9E3-453C-8C69-77085BD04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12202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448226"/>
            <a:ext cx="3703320" cy="7147983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7803CA-EE5D-4B1E-AE20-CD5DD2CACD76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2C3E8C-B9E3-453C-8C69-77085BD04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58894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535519"/>
            <a:ext cx="6309360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677584"/>
            <a:ext cx="6309360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7803CA-EE5D-4B1E-AE20-CD5DD2CACD76}" type="datetimeFigureOut">
              <a:rPr lang="en-US" smtClean="0"/>
              <a:t>12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9322649"/>
            <a:ext cx="246888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2C3E8C-B9E3-453C-8C69-77085BD04B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83352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emf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3" Type="http://schemas.openxmlformats.org/officeDocument/2006/relationships/image" Target="../media/image12.png"/><Relationship Id="rId7" Type="http://schemas.openxmlformats.org/officeDocument/2006/relationships/image" Target="../media/image16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10" Type="http://schemas.openxmlformats.org/officeDocument/2006/relationships/image" Target="../media/image19.png"/><Relationship Id="rId4" Type="http://schemas.openxmlformats.org/officeDocument/2006/relationships/image" Target="../media/image13.png"/><Relationship Id="rId9" Type="http://schemas.openxmlformats.org/officeDocument/2006/relationships/image" Target="../media/image1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3.png"/><Relationship Id="rId4" Type="http://schemas.openxmlformats.org/officeDocument/2006/relationships/image" Target="../media/image2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D85CA5C3-E40A-449A-9050-4C8A4A7B246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86" t="4676" r="1971" b="7485"/>
          <a:stretch/>
        </p:blipFill>
        <p:spPr>
          <a:xfrm>
            <a:off x="434501" y="5601971"/>
            <a:ext cx="3213341" cy="149377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557C482-CA5B-4E5E-88C5-A0F107F73DBA}"/>
              </a:ext>
            </a:extLst>
          </p:cNvPr>
          <p:cNvSpPr txBox="1"/>
          <p:nvPr/>
        </p:nvSpPr>
        <p:spPr>
          <a:xfrm>
            <a:off x="476345" y="5294193"/>
            <a:ext cx="7601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375R1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CC218AC7-945B-4CFB-8206-83A22510F2B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20" t="3910" r="1205" b="4166"/>
          <a:stretch/>
        </p:blipFill>
        <p:spPr>
          <a:xfrm>
            <a:off x="4021391" y="5601972"/>
            <a:ext cx="3142903" cy="1538625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8A51F049-8355-48BB-8BF2-67F310BDF3B2}"/>
              </a:ext>
            </a:extLst>
          </p:cNvPr>
          <p:cNvSpPr txBox="1"/>
          <p:nvPr/>
        </p:nvSpPr>
        <p:spPr>
          <a:xfrm>
            <a:off x="4061634" y="5294192"/>
            <a:ext cx="9444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UCSD354L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0B9A60C-7997-4CCE-AA34-441C4393AAE8}"/>
              </a:ext>
            </a:extLst>
          </p:cNvPr>
          <p:cNvSpPr txBox="1"/>
          <p:nvPr/>
        </p:nvSpPr>
        <p:spPr>
          <a:xfrm>
            <a:off x="5882033" y="71605"/>
            <a:ext cx="135325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E31B71E-5DDB-41DF-92F9-6A088C2B708C}"/>
              </a:ext>
            </a:extLst>
          </p:cNvPr>
          <p:cNvSpPr txBox="1"/>
          <p:nvPr/>
        </p:nvSpPr>
        <p:spPr>
          <a:xfrm>
            <a:off x="161835" y="5294194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C7CA7ED-3943-48D7-97AA-59C78A52BA92}"/>
              </a:ext>
            </a:extLst>
          </p:cNvPr>
          <p:cNvSpPr txBox="1"/>
          <p:nvPr/>
        </p:nvSpPr>
        <p:spPr>
          <a:xfrm>
            <a:off x="3726515" y="5294194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86C1571-BE7C-475A-B8FF-F4811DD7CC15}"/>
              </a:ext>
            </a:extLst>
          </p:cNvPr>
          <p:cNvSpPr txBox="1"/>
          <p:nvPr/>
        </p:nvSpPr>
        <p:spPr>
          <a:xfrm rot="16200000">
            <a:off x="-299961" y="6244279"/>
            <a:ext cx="12752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ell Numbers (%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A086672-1925-4128-B15B-12DE449C26E5}"/>
              </a:ext>
            </a:extLst>
          </p:cNvPr>
          <p:cNvSpPr txBox="1"/>
          <p:nvPr/>
        </p:nvSpPr>
        <p:spPr>
          <a:xfrm rot="16200000">
            <a:off x="3276060" y="6244279"/>
            <a:ext cx="12752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ell Numbers (%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75299E5-C04B-4078-8C51-129F20050F8F}"/>
              </a:ext>
            </a:extLst>
          </p:cNvPr>
          <p:cNvSpPr txBox="1"/>
          <p:nvPr/>
        </p:nvSpPr>
        <p:spPr>
          <a:xfrm>
            <a:off x="2893181" y="6477391"/>
            <a:ext cx="274434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rgbClr val="C00000"/>
                </a:solidFill>
              </a:rPr>
              <a:t>*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B0DB57D-1A42-4BD8-A83F-E4FFE497C1D7}"/>
              </a:ext>
            </a:extLst>
          </p:cNvPr>
          <p:cNvSpPr txBox="1"/>
          <p:nvPr/>
        </p:nvSpPr>
        <p:spPr>
          <a:xfrm>
            <a:off x="630923" y="59866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09E0059-D2B1-461C-8A40-CBEA0350C596}"/>
              </a:ext>
            </a:extLst>
          </p:cNvPr>
          <p:cNvSpPr txBox="1"/>
          <p:nvPr/>
        </p:nvSpPr>
        <p:spPr>
          <a:xfrm>
            <a:off x="3549364" y="59866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12FE6E94-6616-4D05-A5EA-76A758FBA77D}"/>
              </a:ext>
            </a:extLst>
          </p:cNvPr>
          <p:cNvSpPr txBox="1"/>
          <p:nvPr/>
        </p:nvSpPr>
        <p:spPr>
          <a:xfrm>
            <a:off x="3528445" y="286060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1033CF1-54D8-40BE-B1B9-314E1DB5AD86}"/>
              </a:ext>
            </a:extLst>
          </p:cNvPr>
          <p:cNvSpPr txBox="1"/>
          <p:nvPr/>
        </p:nvSpPr>
        <p:spPr>
          <a:xfrm>
            <a:off x="630923" y="288396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33" name="Picture 32">
            <a:extLst>
              <a:ext uri="{FF2B5EF4-FFF2-40B4-BE49-F238E27FC236}">
                <a16:creationId xmlns:a16="http://schemas.microsoft.com/office/drawing/2014/main" id="{FE01DC72-4BCE-41FA-ACF2-843A6178EBD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26574" y="3004653"/>
            <a:ext cx="2575283" cy="2037077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62B37C14-5F56-493D-A12D-91317AE0EC8D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5114" t="1532" r="7329" b="4394"/>
          <a:stretch/>
        </p:blipFill>
        <p:spPr>
          <a:xfrm>
            <a:off x="3928783" y="8293906"/>
            <a:ext cx="1447306" cy="984854"/>
          </a:xfrm>
          <a:prstGeom prst="rect">
            <a:avLst/>
          </a:prstGeom>
        </p:spPr>
      </p:pic>
      <p:sp>
        <p:nvSpPr>
          <p:cNvPr id="34" name="TextBox 33">
            <a:extLst>
              <a:ext uri="{FF2B5EF4-FFF2-40B4-BE49-F238E27FC236}">
                <a16:creationId xmlns:a16="http://schemas.microsoft.com/office/drawing/2014/main" id="{28CFD28D-6DD1-47F4-88E3-6A159EC3828B}"/>
              </a:ext>
            </a:extLst>
          </p:cNvPr>
          <p:cNvSpPr txBox="1"/>
          <p:nvPr/>
        </p:nvSpPr>
        <p:spPr>
          <a:xfrm>
            <a:off x="487144" y="7734759"/>
            <a:ext cx="7601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375R1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459F7EC6-B2FF-440D-B1F3-FCA16E978D7E}"/>
              </a:ext>
            </a:extLst>
          </p:cNvPr>
          <p:cNvSpPr txBox="1"/>
          <p:nvPr/>
        </p:nvSpPr>
        <p:spPr>
          <a:xfrm>
            <a:off x="4112137" y="7734759"/>
            <a:ext cx="9444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UCSD354L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A6921180-0E8A-4C80-A5B5-783540907764}"/>
              </a:ext>
            </a:extLst>
          </p:cNvPr>
          <p:cNvSpPr txBox="1"/>
          <p:nvPr/>
        </p:nvSpPr>
        <p:spPr>
          <a:xfrm>
            <a:off x="172634" y="7734760"/>
            <a:ext cx="3241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D6D7C49-3726-49C2-B306-84F9D1B4C306}"/>
              </a:ext>
            </a:extLst>
          </p:cNvPr>
          <p:cNvSpPr txBox="1"/>
          <p:nvPr/>
        </p:nvSpPr>
        <p:spPr>
          <a:xfrm>
            <a:off x="3777018" y="7734761"/>
            <a:ext cx="2343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004F754B-4C85-4CF3-9102-F513CFA36386}"/>
              </a:ext>
            </a:extLst>
          </p:cNvPr>
          <p:cNvSpPr txBox="1"/>
          <p:nvPr/>
        </p:nvSpPr>
        <p:spPr>
          <a:xfrm>
            <a:off x="2312465" y="7734759"/>
            <a:ext cx="7601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375R1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105982A6-CC73-400D-80BF-418FD0D45440}"/>
              </a:ext>
            </a:extLst>
          </p:cNvPr>
          <p:cNvSpPr txBox="1"/>
          <p:nvPr/>
        </p:nvSpPr>
        <p:spPr>
          <a:xfrm>
            <a:off x="5905271" y="7734759"/>
            <a:ext cx="9444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UCSD354L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CE616C41-1DBA-4F6D-B04A-D6FB5A81BF39}"/>
              </a:ext>
            </a:extLst>
          </p:cNvPr>
          <p:cNvSpPr txBox="1"/>
          <p:nvPr/>
        </p:nvSpPr>
        <p:spPr>
          <a:xfrm>
            <a:off x="1997955" y="773476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FDB19E69-2718-4E7B-939D-AF940843B906}"/>
              </a:ext>
            </a:extLst>
          </p:cNvPr>
          <p:cNvSpPr txBox="1"/>
          <p:nvPr/>
        </p:nvSpPr>
        <p:spPr>
          <a:xfrm>
            <a:off x="5570152" y="7734761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id="{DFF0A58E-AD77-4BC9-AEB7-B6CC0A24A2B2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5114" t="2013" r="7329" b="4405"/>
          <a:stretch/>
        </p:blipFill>
        <p:spPr>
          <a:xfrm>
            <a:off x="340024" y="8314101"/>
            <a:ext cx="1440490" cy="980216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6E55E965-BEC7-42A9-A517-7EC585763FE3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5050" t="4381" r="7707" b="4642"/>
          <a:stretch/>
        </p:blipFill>
        <p:spPr>
          <a:xfrm>
            <a:off x="2060570" y="8293906"/>
            <a:ext cx="1484191" cy="980217"/>
          </a:xfrm>
          <a:prstGeom prst="rect">
            <a:avLst/>
          </a:prstGeom>
        </p:spPr>
      </p:pic>
      <p:pic>
        <p:nvPicPr>
          <p:cNvPr id="42" name="Picture 41">
            <a:extLst>
              <a:ext uri="{FF2B5EF4-FFF2-40B4-BE49-F238E27FC236}">
                <a16:creationId xmlns:a16="http://schemas.microsoft.com/office/drawing/2014/main" id="{FE0E2CA1-2E1A-4376-A658-11329AF7D064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4785" t="4889" r="7414" b="4134"/>
          <a:stretch/>
        </p:blipFill>
        <p:spPr>
          <a:xfrm>
            <a:off x="5670496" y="8299144"/>
            <a:ext cx="1493659" cy="980217"/>
          </a:xfrm>
          <a:prstGeom prst="rect">
            <a:avLst/>
          </a:prstGeom>
        </p:spPr>
      </p:pic>
      <p:sp>
        <p:nvSpPr>
          <p:cNvPr id="43" name="TextBox 42">
            <a:extLst>
              <a:ext uri="{FF2B5EF4-FFF2-40B4-BE49-F238E27FC236}">
                <a16:creationId xmlns:a16="http://schemas.microsoft.com/office/drawing/2014/main" id="{507D2FDA-6E6F-4D25-BC41-4285B924CBCA}"/>
              </a:ext>
            </a:extLst>
          </p:cNvPr>
          <p:cNvSpPr txBox="1"/>
          <p:nvPr/>
        </p:nvSpPr>
        <p:spPr>
          <a:xfrm>
            <a:off x="602840" y="8053109"/>
            <a:ext cx="12068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-AKT (Thr308)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AC72766F-D78A-47E1-9AEB-C6597302D7FB}"/>
              </a:ext>
            </a:extLst>
          </p:cNvPr>
          <p:cNvSpPr txBox="1"/>
          <p:nvPr/>
        </p:nvSpPr>
        <p:spPr>
          <a:xfrm>
            <a:off x="4156073" y="8053109"/>
            <a:ext cx="12068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-AKT (Thr308)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9EE0789B-3CC3-4716-A019-80D794469D17}"/>
              </a:ext>
            </a:extLst>
          </p:cNvPr>
          <p:cNvSpPr txBox="1"/>
          <p:nvPr/>
        </p:nvSpPr>
        <p:spPr>
          <a:xfrm>
            <a:off x="2375836" y="8042536"/>
            <a:ext cx="12615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-AMPK (Thr172)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06B85C99-5FB8-4691-B938-B16FCC5ECFB7}"/>
              </a:ext>
            </a:extLst>
          </p:cNvPr>
          <p:cNvSpPr txBox="1"/>
          <p:nvPr/>
        </p:nvSpPr>
        <p:spPr>
          <a:xfrm>
            <a:off x="5902757" y="8038688"/>
            <a:ext cx="126153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-AMPK (Thr172)</a:t>
            </a:r>
          </a:p>
        </p:txBody>
      </p:sp>
      <p:pic>
        <p:nvPicPr>
          <p:cNvPr id="54" name="Picture 53">
            <a:extLst>
              <a:ext uri="{FF2B5EF4-FFF2-40B4-BE49-F238E27FC236}">
                <a16:creationId xmlns:a16="http://schemas.microsoft.com/office/drawing/2014/main" id="{FA07397F-F208-42F7-822D-BD186E654B1D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80258" y="765540"/>
            <a:ext cx="2576771" cy="2045829"/>
          </a:xfrm>
          <a:prstGeom prst="rect">
            <a:avLst/>
          </a:prstGeom>
        </p:spPr>
      </p:pic>
      <p:pic>
        <p:nvPicPr>
          <p:cNvPr id="63" name="Picture 62">
            <a:extLst>
              <a:ext uri="{FF2B5EF4-FFF2-40B4-BE49-F238E27FC236}">
                <a16:creationId xmlns:a16="http://schemas.microsoft.com/office/drawing/2014/main" id="{99A0983F-9299-40B6-9C9C-D53F2D4436DA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657600" y="765540"/>
            <a:ext cx="2572542" cy="2058034"/>
          </a:xfrm>
          <a:prstGeom prst="rect">
            <a:avLst/>
          </a:prstGeom>
        </p:spPr>
      </p:pic>
      <p:pic>
        <p:nvPicPr>
          <p:cNvPr id="64" name="Picture 63">
            <a:extLst>
              <a:ext uri="{FF2B5EF4-FFF2-40B4-BE49-F238E27FC236}">
                <a16:creationId xmlns:a16="http://schemas.microsoft.com/office/drawing/2014/main" id="{368E946F-9292-4A3F-ACA8-75DDC648E50A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t="12565"/>
          <a:stretch/>
        </p:blipFill>
        <p:spPr>
          <a:xfrm>
            <a:off x="699514" y="3098598"/>
            <a:ext cx="2575283" cy="201165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A042EEFB-F7F7-4381-BE1F-1207ABAD9E55}"/>
              </a:ext>
            </a:extLst>
          </p:cNvPr>
          <p:cNvSpPr txBox="1"/>
          <p:nvPr/>
        </p:nvSpPr>
        <p:spPr>
          <a:xfrm rot="16200000">
            <a:off x="49189" y="8455059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rea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37EAC1C4-7BA6-47BB-B2CB-CA29FAE3B41D}"/>
              </a:ext>
            </a:extLst>
          </p:cNvPr>
          <p:cNvSpPr txBox="1"/>
          <p:nvPr/>
        </p:nvSpPr>
        <p:spPr>
          <a:xfrm rot="16200000">
            <a:off x="3636812" y="8429023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rea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35E0B666-85A0-4B0B-9B55-8C64482735CE}"/>
              </a:ext>
            </a:extLst>
          </p:cNvPr>
          <p:cNvSpPr txBox="1"/>
          <p:nvPr/>
        </p:nvSpPr>
        <p:spPr>
          <a:xfrm rot="16200000">
            <a:off x="1761981" y="8416828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rea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7E989ECB-20EB-4884-A79D-886EF5AC3C8F}"/>
              </a:ext>
            </a:extLst>
          </p:cNvPr>
          <p:cNvSpPr txBox="1"/>
          <p:nvPr/>
        </p:nvSpPr>
        <p:spPr>
          <a:xfrm rot="16200000">
            <a:off x="5362956" y="8407390"/>
            <a:ext cx="4683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rea</a:t>
            </a:r>
          </a:p>
        </p:txBody>
      </p:sp>
    </p:spTree>
    <p:extLst>
      <p:ext uri="{BB962C8B-B14F-4D97-AF65-F5344CB8AC3E}">
        <p14:creationId xmlns:p14="http://schemas.microsoft.com/office/powerpoint/2010/main" val="22258548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F0F883FD-C517-47D0-87D7-54DEFF2B062F}"/>
              </a:ext>
            </a:extLst>
          </p:cNvPr>
          <p:cNvSpPr txBox="1"/>
          <p:nvPr/>
        </p:nvSpPr>
        <p:spPr>
          <a:xfrm>
            <a:off x="5882033" y="71605"/>
            <a:ext cx="135325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A099D2D-7C4D-46FD-984F-44BBE8B3C15E}"/>
              </a:ext>
            </a:extLst>
          </p:cNvPr>
          <p:cNvSpPr txBox="1"/>
          <p:nvPr/>
        </p:nvSpPr>
        <p:spPr>
          <a:xfrm>
            <a:off x="361537" y="5296626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AF80A935-797D-4B82-8137-ECC677C54EA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054" t="2180" r="3896" b="2180"/>
          <a:stretch/>
        </p:blipFill>
        <p:spPr>
          <a:xfrm>
            <a:off x="734563" y="5530261"/>
            <a:ext cx="2339146" cy="1799531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081F8F90-EBF5-450A-98EF-49D015D1BB05}"/>
              </a:ext>
            </a:extLst>
          </p:cNvPr>
          <p:cNvSpPr txBox="1"/>
          <p:nvPr/>
        </p:nvSpPr>
        <p:spPr>
          <a:xfrm rot="16200000">
            <a:off x="38447" y="6159101"/>
            <a:ext cx="1229824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ell Growth (%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B0C3506-E4EA-4933-B470-3ACB59B3A071}"/>
              </a:ext>
            </a:extLst>
          </p:cNvPr>
          <p:cNvSpPr txBox="1"/>
          <p:nvPr/>
        </p:nvSpPr>
        <p:spPr>
          <a:xfrm>
            <a:off x="1460117" y="7295667"/>
            <a:ext cx="11368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STN / ETMR  (</a:t>
            </a:r>
            <a:r>
              <a:rPr lang="en-US" sz="1000" b="1" dirty="0" err="1"/>
              <a:t>nM</a:t>
            </a:r>
            <a:r>
              <a:rPr lang="en-US" sz="1000" b="1" dirty="0"/>
              <a:t>)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5681FA3F-B014-4B07-B66E-AA905162C14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361" t="2972" r="3596" b="2138"/>
          <a:stretch/>
        </p:blipFill>
        <p:spPr>
          <a:xfrm>
            <a:off x="806131" y="3078234"/>
            <a:ext cx="2470697" cy="1697428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73DCE5BA-D817-4602-81BC-D4D97A059C8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229" t="2693" r="3727" b="1861"/>
          <a:stretch/>
        </p:blipFill>
        <p:spPr>
          <a:xfrm>
            <a:off x="4204960" y="3068306"/>
            <a:ext cx="2470697" cy="1707356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ED19AF61-9F6C-41F5-8560-6CC82FA99F47}"/>
              </a:ext>
            </a:extLst>
          </p:cNvPr>
          <p:cNvSpPr txBox="1"/>
          <p:nvPr/>
        </p:nvSpPr>
        <p:spPr>
          <a:xfrm>
            <a:off x="436751" y="271761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8A75B58-F68E-4D3E-87AC-A8C271F158AF}"/>
              </a:ext>
            </a:extLst>
          </p:cNvPr>
          <p:cNvSpPr txBox="1"/>
          <p:nvPr/>
        </p:nvSpPr>
        <p:spPr>
          <a:xfrm>
            <a:off x="3778120" y="271761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D322554-2D3B-4371-A1D8-DBE09A04C372}"/>
              </a:ext>
            </a:extLst>
          </p:cNvPr>
          <p:cNvSpPr txBox="1"/>
          <p:nvPr/>
        </p:nvSpPr>
        <p:spPr>
          <a:xfrm rot="16200000">
            <a:off x="99012" y="3666022"/>
            <a:ext cx="1229824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ell Growth (%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1A56C84-97AB-4DC2-9B0F-45420DC33196}"/>
              </a:ext>
            </a:extLst>
          </p:cNvPr>
          <p:cNvSpPr txBox="1"/>
          <p:nvPr/>
        </p:nvSpPr>
        <p:spPr>
          <a:xfrm rot="16200000">
            <a:off x="3488085" y="3661842"/>
            <a:ext cx="1229824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ell Growth (%)</a:t>
            </a:r>
          </a:p>
        </p:txBody>
      </p:sp>
      <p:sp>
        <p:nvSpPr>
          <p:cNvPr id="20" name="Right Bracket 19">
            <a:extLst>
              <a:ext uri="{FF2B5EF4-FFF2-40B4-BE49-F238E27FC236}">
                <a16:creationId xmlns:a16="http://schemas.microsoft.com/office/drawing/2014/main" id="{CC1FCD9C-B95E-4844-BE73-1BF285363B0F}"/>
              </a:ext>
            </a:extLst>
          </p:cNvPr>
          <p:cNvSpPr/>
          <p:nvPr/>
        </p:nvSpPr>
        <p:spPr>
          <a:xfrm>
            <a:off x="3278015" y="3415156"/>
            <a:ext cx="45719" cy="307777"/>
          </a:xfrm>
          <a:prstGeom prst="rightBracket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E223C42-F6B5-4189-A400-73993A25653C}"/>
              </a:ext>
            </a:extLst>
          </p:cNvPr>
          <p:cNvSpPr txBox="1"/>
          <p:nvPr/>
        </p:nvSpPr>
        <p:spPr>
          <a:xfrm>
            <a:off x="3254842" y="3438723"/>
            <a:ext cx="1841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*</a:t>
            </a:r>
          </a:p>
        </p:txBody>
      </p:sp>
      <p:sp>
        <p:nvSpPr>
          <p:cNvPr id="24" name="Right Bracket 23">
            <a:extLst>
              <a:ext uri="{FF2B5EF4-FFF2-40B4-BE49-F238E27FC236}">
                <a16:creationId xmlns:a16="http://schemas.microsoft.com/office/drawing/2014/main" id="{4427C157-C429-4130-8815-D368F3061797}"/>
              </a:ext>
            </a:extLst>
          </p:cNvPr>
          <p:cNvSpPr/>
          <p:nvPr/>
        </p:nvSpPr>
        <p:spPr>
          <a:xfrm>
            <a:off x="6686600" y="3518303"/>
            <a:ext cx="45719" cy="359666"/>
          </a:xfrm>
          <a:prstGeom prst="rightBracket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720AC64-61B4-4EEE-8E67-29B1AA17B6B6}"/>
              </a:ext>
            </a:extLst>
          </p:cNvPr>
          <p:cNvSpPr txBox="1"/>
          <p:nvPr/>
        </p:nvSpPr>
        <p:spPr>
          <a:xfrm>
            <a:off x="6663427" y="3549082"/>
            <a:ext cx="1841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C00000"/>
                </a:solidFill>
              </a:rPr>
              <a:t>*</a:t>
            </a:r>
          </a:p>
        </p:txBody>
      </p:sp>
      <p:sp>
        <p:nvSpPr>
          <p:cNvPr id="32" name="Right Bracket 31">
            <a:extLst>
              <a:ext uri="{FF2B5EF4-FFF2-40B4-BE49-F238E27FC236}">
                <a16:creationId xmlns:a16="http://schemas.microsoft.com/office/drawing/2014/main" id="{CB1E9557-A3BE-4C53-B87D-DD27C5BA49F8}"/>
              </a:ext>
            </a:extLst>
          </p:cNvPr>
          <p:cNvSpPr/>
          <p:nvPr/>
        </p:nvSpPr>
        <p:spPr>
          <a:xfrm>
            <a:off x="3066515" y="5813308"/>
            <a:ext cx="45719" cy="1010261"/>
          </a:xfrm>
          <a:prstGeom prst="rightBracket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1FA359B0-3C4C-425B-85E5-B21A1DA3691A}"/>
              </a:ext>
            </a:extLst>
          </p:cNvPr>
          <p:cNvSpPr txBox="1"/>
          <p:nvPr/>
        </p:nvSpPr>
        <p:spPr>
          <a:xfrm>
            <a:off x="3051559" y="6174307"/>
            <a:ext cx="1841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C00000"/>
                </a:solidFill>
              </a:rPr>
              <a:t>*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98A8E0F-41C5-447F-BD29-83DE61F28158}"/>
              </a:ext>
            </a:extLst>
          </p:cNvPr>
          <p:cNvSpPr txBox="1"/>
          <p:nvPr/>
        </p:nvSpPr>
        <p:spPr>
          <a:xfrm>
            <a:off x="1576187" y="4736171"/>
            <a:ext cx="10647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IACS / STN  (</a:t>
            </a:r>
            <a:r>
              <a:rPr lang="en-US" sz="1000" b="1" dirty="0" err="1"/>
              <a:t>nM</a:t>
            </a:r>
            <a:r>
              <a:rPr lang="en-US" sz="1000" b="1" dirty="0"/>
              <a:t>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A30A206-09FA-42AC-AEAF-D66A5A9DB4D5}"/>
              </a:ext>
            </a:extLst>
          </p:cNvPr>
          <p:cNvSpPr txBox="1"/>
          <p:nvPr/>
        </p:nvSpPr>
        <p:spPr>
          <a:xfrm>
            <a:off x="4995965" y="4736171"/>
            <a:ext cx="10647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/>
              <a:t>IACS / STN  (</a:t>
            </a:r>
            <a:r>
              <a:rPr lang="en-US" sz="1000" b="1" dirty="0" err="1"/>
              <a:t>nM</a:t>
            </a:r>
            <a:r>
              <a:rPr lang="en-US" sz="1000" b="1" dirty="0"/>
              <a:t>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9960D87-B479-4E90-9AE2-FA7A84BAF895}"/>
              </a:ext>
            </a:extLst>
          </p:cNvPr>
          <p:cNvSpPr txBox="1"/>
          <p:nvPr/>
        </p:nvSpPr>
        <p:spPr>
          <a:xfrm>
            <a:off x="1563936" y="5296626"/>
            <a:ext cx="7601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375R1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C69ECFEA-6610-449F-9A43-834A5A229937}"/>
              </a:ext>
            </a:extLst>
          </p:cNvPr>
          <p:cNvSpPr txBox="1"/>
          <p:nvPr/>
        </p:nvSpPr>
        <p:spPr>
          <a:xfrm>
            <a:off x="1718853" y="2717615"/>
            <a:ext cx="7793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MEL624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F7EB91F-17AF-42FF-BFF8-50471E83C388}"/>
              </a:ext>
            </a:extLst>
          </p:cNvPr>
          <p:cNvSpPr txBox="1"/>
          <p:nvPr/>
        </p:nvSpPr>
        <p:spPr>
          <a:xfrm>
            <a:off x="5085568" y="2717614"/>
            <a:ext cx="8707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WM1799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1CA40D31-ED80-4B67-BB32-FB2A6FBDDFFB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293" t="2272" r="3070" b="19949"/>
          <a:stretch/>
        </p:blipFill>
        <p:spPr>
          <a:xfrm>
            <a:off x="806130" y="784671"/>
            <a:ext cx="2304111" cy="1605896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58C4D778-D549-4C98-931C-BBBF283889A6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2325" t="2388" r="4292" b="19660"/>
          <a:stretch/>
        </p:blipFill>
        <p:spPr>
          <a:xfrm>
            <a:off x="4204960" y="792079"/>
            <a:ext cx="2259906" cy="1596250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0CB7C1E8-4C46-44C4-8344-C5C6BFFB0F79}"/>
              </a:ext>
            </a:extLst>
          </p:cNvPr>
          <p:cNvSpPr txBox="1"/>
          <p:nvPr/>
        </p:nvSpPr>
        <p:spPr>
          <a:xfrm>
            <a:off x="436108" y="50226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0231F6A-C4CB-4268-8E17-CB412D7EB7F9}"/>
              </a:ext>
            </a:extLst>
          </p:cNvPr>
          <p:cNvSpPr txBox="1"/>
          <p:nvPr/>
        </p:nvSpPr>
        <p:spPr>
          <a:xfrm>
            <a:off x="3779425" y="50226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267FBFF-DFA0-4ABA-A0BE-2BFC115B28DF}"/>
              </a:ext>
            </a:extLst>
          </p:cNvPr>
          <p:cNvSpPr txBox="1"/>
          <p:nvPr/>
        </p:nvSpPr>
        <p:spPr>
          <a:xfrm>
            <a:off x="1632569" y="502266"/>
            <a:ext cx="7793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MEL624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7CFC4093-2CEF-4A70-B5EF-4A2FC0D2714D}"/>
              </a:ext>
            </a:extLst>
          </p:cNvPr>
          <p:cNvSpPr txBox="1"/>
          <p:nvPr/>
        </p:nvSpPr>
        <p:spPr>
          <a:xfrm>
            <a:off x="4999284" y="502265"/>
            <a:ext cx="8707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WM1799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FD94B281-AF7F-4DDD-8DA9-4B768B374990}"/>
              </a:ext>
            </a:extLst>
          </p:cNvPr>
          <p:cNvSpPr txBox="1"/>
          <p:nvPr/>
        </p:nvSpPr>
        <p:spPr>
          <a:xfrm rot="16200000">
            <a:off x="69997" y="1485195"/>
            <a:ext cx="12570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% Fuel  Oxidation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B32845B8-1081-44AB-937B-8AFCEED94723}"/>
              </a:ext>
            </a:extLst>
          </p:cNvPr>
          <p:cNvSpPr txBox="1"/>
          <p:nvPr/>
        </p:nvSpPr>
        <p:spPr>
          <a:xfrm rot="16200000">
            <a:off x="3503310" y="1485195"/>
            <a:ext cx="12570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% Fuel  Oxidation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DBB967B5-17CA-4DF6-AF51-198AFB69CE44}"/>
              </a:ext>
            </a:extLst>
          </p:cNvPr>
          <p:cNvSpPr txBox="1"/>
          <p:nvPr/>
        </p:nvSpPr>
        <p:spPr>
          <a:xfrm>
            <a:off x="4595757" y="2310063"/>
            <a:ext cx="4555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GLC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CB9C168D-87EE-4983-A3A7-DFAA54E66A8A}"/>
              </a:ext>
            </a:extLst>
          </p:cNvPr>
          <p:cNvSpPr txBox="1"/>
          <p:nvPr/>
        </p:nvSpPr>
        <p:spPr>
          <a:xfrm>
            <a:off x="5224371" y="2310062"/>
            <a:ext cx="4555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GLN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7B4A9DB7-9A54-4967-AE41-C4B43E7CDAEB}"/>
              </a:ext>
            </a:extLst>
          </p:cNvPr>
          <p:cNvSpPr txBox="1"/>
          <p:nvPr/>
        </p:nvSpPr>
        <p:spPr>
          <a:xfrm>
            <a:off x="5966474" y="2310062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A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AE8455A2-2046-4DD4-A6AA-8554473B0FB6}"/>
              </a:ext>
            </a:extLst>
          </p:cNvPr>
          <p:cNvSpPr txBox="1"/>
          <p:nvPr/>
        </p:nvSpPr>
        <p:spPr>
          <a:xfrm>
            <a:off x="1207143" y="2307641"/>
            <a:ext cx="4555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GLC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0BDFBDA4-CAEA-453A-B216-239355648523}"/>
              </a:ext>
            </a:extLst>
          </p:cNvPr>
          <p:cNvSpPr txBox="1"/>
          <p:nvPr/>
        </p:nvSpPr>
        <p:spPr>
          <a:xfrm>
            <a:off x="1853229" y="2307640"/>
            <a:ext cx="45557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GLN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8FE45C2F-34E5-4AD9-8532-8E17E4EB731C}"/>
              </a:ext>
            </a:extLst>
          </p:cNvPr>
          <p:cNvSpPr txBox="1"/>
          <p:nvPr/>
        </p:nvSpPr>
        <p:spPr>
          <a:xfrm>
            <a:off x="2572035" y="2307640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A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B8DDD42B-0A4B-470F-804A-92CC8FD8C8CC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436" t="2099" r="2218" b="3102"/>
          <a:stretch/>
        </p:blipFill>
        <p:spPr>
          <a:xfrm>
            <a:off x="3559540" y="5484029"/>
            <a:ext cx="3550746" cy="1688331"/>
          </a:xfrm>
          <a:prstGeom prst="rect">
            <a:avLst/>
          </a:prstGeom>
        </p:spPr>
      </p:pic>
      <p:sp>
        <p:nvSpPr>
          <p:cNvPr id="43" name="TextBox 42">
            <a:extLst>
              <a:ext uri="{FF2B5EF4-FFF2-40B4-BE49-F238E27FC236}">
                <a16:creationId xmlns:a16="http://schemas.microsoft.com/office/drawing/2014/main" id="{8FB1467A-6948-48D7-A7C0-A5798617DAC9}"/>
              </a:ext>
            </a:extLst>
          </p:cNvPr>
          <p:cNvSpPr txBox="1"/>
          <p:nvPr/>
        </p:nvSpPr>
        <p:spPr>
          <a:xfrm>
            <a:off x="3308072" y="5299482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A7A5B51B-C241-4CD3-A479-6851E890B285}"/>
              </a:ext>
            </a:extLst>
          </p:cNvPr>
          <p:cNvSpPr txBox="1"/>
          <p:nvPr/>
        </p:nvSpPr>
        <p:spPr>
          <a:xfrm>
            <a:off x="4987948" y="5296626"/>
            <a:ext cx="7601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375R1</a:t>
            </a:r>
          </a:p>
        </p:txBody>
      </p:sp>
      <p:pic>
        <p:nvPicPr>
          <p:cNvPr id="45" name="Picture 44">
            <a:extLst>
              <a:ext uri="{FF2B5EF4-FFF2-40B4-BE49-F238E27FC236}">
                <a16:creationId xmlns:a16="http://schemas.microsoft.com/office/drawing/2014/main" id="{4EA628CF-7BFB-49D0-876A-EAF1D375F9DE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715" t="1495" r="715" b="1615"/>
          <a:stretch/>
        </p:blipFill>
        <p:spPr>
          <a:xfrm>
            <a:off x="5147338" y="7910604"/>
            <a:ext cx="1974378" cy="1539045"/>
          </a:xfrm>
          <a:prstGeom prst="rect">
            <a:avLst/>
          </a:prstGeom>
        </p:spPr>
      </p:pic>
      <p:sp>
        <p:nvSpPr>
          <p:cNvPr id="47" name="TextBox 46">
            <a:extLst>
              <a:ext uri="{FF2B5EF4-FFF2-40B4-BE49-F238E27FC236}">
                <a16:creationId xmlns:a16="http://schemas.microsoft.com/office/drawing/2014/main" id="{02EC8862-E249-4851-B99F-B2D448E2013B}"/>
              </a:ext>
            </a:extLst>
          </p:cNvPr>
          <p:cNvSpPr txBox="1"/>
          <p:nvPr/>
        </p:nvSpPr>
        <p:spPr>
          <a:xfrm>
            <a:off x="287561" y="7717247"/>
            <a:ext cx="3241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7F1CF579-6461-4D41-97A6-FB7B2F3956D1}"/>
              </a:ext>
            </a:extLst>
          </p:cNvPr>
          <p:cNvSpPr txBox="1"/>
          <p:nvPr/>
        </p:nvSpPr>
        <p:spPr>
          <a:xfrm>
            <a:off x="2621531" y="771392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0BA799DE-E812-401E-ABC1-2FD3EB6C1183}"/>
              </a:ext>
            </a:extLst>
          </p:cNvPr>
          <p:cNvSpPr txBox="1"/>
          <p:nvPr/>
        </p:nvSpPr>
        <p:spPr>
          <a:xfrm rot="16200000">
            <a:off x="2135921" y="8385459"/>
            <a:ext cx="12531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 [U-</a:t>
            </a:r>
            <a:r>
              <a:rPr lang="en-US" sz="1200" b="1" baseline="30000" dirty="0"/>
              <a:t>13</a:t>
            </a:r>
            <a:r>
              <a:rPr lang="en-US" sz="1200" b="1" dirty="0"/>
              <a:t>C]-GLC</a:t>
            </a:r>
          </a:p>
          <a:p>
            <a:pPr algn="ctr"/>
            <a:r>
              <a:rPr lang="en-US" sz="1200" b="1" dirty="0"/>
              <a:t>(Acetoacetate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45C518A-E6C2-47D9-9B88-B89C587A28EA}"/>
              </a:ext>
            </a:extLst>
          </p:cNvPr>
          <p:cNvSpPr txBox="1"/>
          <p:nvPr/>
        </p:nvSpPr>
        <p:spPr>
          <a:xfrm rot="16200000">
            <a:off x="2770292" y="6046089"/>
            <a:ext cx="145584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Viable cell numbers 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E618B1FF-7B18-4475-A786-60E9540FFD6A}"/>
              </a:ext>
            </a:extLst>
          </p:cNvPr>
          <p:cNvSpPr txBox="1"/>
          <p:nvPr/>
        </p:nvSpPr>
        <p:spPr>
          <a:xfrm rot="16200000">
            <a:off x="1662388" y="1117217"/>
            <a:ext cx="2685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0070C0"/>
                </a:solidFill>
              </a:rPr>
              <a:t>*</a:t>
            </a:r>
          </a:p>
        </p:txBody>
      </p: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ED7D72D3-76D8-4E40-BE9A-3D337134E6CD}"/>
              </a:ext>
            </a:extLst>
          </p:cNvPr>
          <p:cNvCxnSpPr>
            <a:cxnSpLocks/>
          </p:cNvCxnSpPr>
          <p:nvPr/>
        </p:nvCxnSpPr>
        <p:spPr>
          <a:xfrm>
            <a:off x="1434930" y="1333318"/>
            <a:ext cx="64455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DFDCFC8A-D36A-4AE5-B788-8BDD940B3E89}"/>
              </a:ext>
            </a:extLst>
          </p:cNvPr>
          <p:cNvCxnSpPr>
            <a:cxnSpLocks/>
          </p:cNvCxnSpPr>
          <p:nvPr/>
        </p:nvCxnSpPr>
        <p:spPr>
          <a:xfrm>
            <a:off x="2079484" y="1259976"/>
            <a:ext cx="670645" cy="539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id="{C257A6AD-5B31-44ED-AABC-17097362C69E}"/>
              </a:ext>
            </a:extLst>
          </p:cNvPr>
          <p:cNvSpPr txBox="1"/>
          <p:nvPr/>
        </p:nvSpPr>
        <p:spPr>
          <a:xfrm rot="16200000">
            <a:off x="2333376" y="1043826"/>
            <a:ext cx="2685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EF853D"/>
                </a:solidFill>
              </a:rPr>
              <a:t>*</a:t>
            </a:r>
          </a:p>
        </p:txBody>
      </p: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95192072-F0FC-4167-ACC8-B5946F340A5F}"/>
              </a:ext>
            </a:extLst>
          </p:cNvPr>
          <p:cNvCxnSpPr>
            <a:cxnSpLocks/>
          </p:cNvCxnSpPr>
          <p:nvPr/>
        </p:nvCxnSpPr>
        <p:spPr>
          <a:xfrm>
            <a:off x="1434930" y="1117687"/>
            <a:ext cx="131519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C2CFDF4D-11AA-43C8-AFC5-E62B58C46CDC}"/>
              </a:ext>
            </a:extLst>
          </p:cNvPr>
          <p:cNvSpPr txBox="1"/>
          <p:nvPr/>
        </p:nvSpPr>
        <p:spPr>
          <a:xfrm rot="16200000">
            <a:off x="1822129" y="892806"/>
            <a:ext cx="2685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0070C0"/>
                </a:solidFill>
              </a:rPr>
              <a:t>*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25B2AC4C-752D-4E65-87D2-81CC592F7919}"/>
              </a:ext>
            </a:extLst>
          </p:cNvPr>
          <p:cNvSpPr txBox="1"/>
          <p:nvPr/>
        </p:nvSpPr>
        <p:spPr>
          <a:xfrm rot="16200000">
            <a:off x="2035925" y="897862"/>
            <a:ext cx="2685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EF853D"/>
                </a:solidFill>
              </a:rPr>
              <a:t>*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7A612BA0-4F95-4289-9525-BA45CC66F20D}"/>
              </a:ext>
            </a:extLst>
          </p:cNvPr>
          <p:cNvSpPr txBox="1"/>
          <p:nvPr/>
        </p:nvSpPr>
        <p:spPr>
          <a:xfrm rot="16200000">
            <a:off x="4991710" y="954680"/>
            <a:ext cx="2685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0070C0"/>
                </a:solidFill>
              </a:rPr>
              <a:t>*</a:t>
            </a:r>
          </a:p>
        </p:txBody>
      </p: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21F5AFAC-F4CC-4D9D-A301-DB09CFD6B511}"/>
              </a:ext>
            </a:extLst>
          </p:cNvPr>
          <p:cNvCxnSpPr>
            <a:cxnSpLocks/>
          </p:cNvCxnSpPr>
          <p:nvPr/>
        </p:nvCxnSpPr>
        <p:spPr>
          <a:xfrm>
            <a:off x="4848944" y="1158310"/>
            <a:ext cx="64455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31466A99-7884-4FCD-92F8-B34058186E85}"/>
              </a:ext>
            </a:extLst>
          </p:cNvPr>
          <p:cNvCxnSpPr>
            <a:cxnSpLocks/>
          </p:cNvCxnSpPr>
          <p:nvPr/>
        </p:nvCxnSpPr>
        <p:spPr>
          <a:xfrm>
            <a:off x="4832530" y="1040265"/>
            <a:ext cx="131519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:a16="http://schemas.microsoft.com/office/drawing/2014/main" id="{9DFCC988-2580-4F23-817E-496D864B7D04}"/>
              </a:ext>
            </a:extLst>
          </p:cNvPr>
          <p:cNvSpPr txBox="1"/>
          <p:nvPr/>
        </p:nvSpPr>
        <p:spPr>
          <a:xfrm rot="16200000">
            <a:off x="5448031" y="838191"/>
            <a:ext cx="2685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EF853D"/>
                </a:solidFill>
              </a:rPr>
              <a:t>*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D6EAF7D7-CAA8-4FA8-A446-A1246F26DB0F}"/>
              </a:ext>
            </a:extLst>
          </p:cNvPr>
          <p:cNvSpPr txBox="1"/>
          <p:nvPr/>
        </p:nvSpPr>
        <p:spPr>
          <a:xfrm rot="16200000">
            <a:off x="5151358" y="953328"/>
            <a:ext cx="26853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srgbClr val="EF853D"/>
                </a:solidFill>
              </a:rPr>
              <a:t>*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C5E011FE-24F2-4780-BB5C-9D599E6689E7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958" t="2337" r="786" b="1446"/>
          <a:stretch/>
        </p:blipFill>
        <p:spPr>
          <a:xfrm>
            <a:off x="2962301" y="7992568"/>
            <a:ext cx="1930962" cy="1485357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0A26E72B-0588-420C-9018-F2CE1B5E1AAA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904" t="2072" r="1412" b="1272"/>
          <a:stretch/>
        </p:blipFill>
        <p:spPr>
          <a:xfrm>
            <a:off x="464407" y="8006025"/>
            <a:ext cx="2069389" cy="1483233"/>
          </a:xfrm>
          <a:prstGeom prst="rect">
            <a:avLst/>
          </a:prstGeom>
        </p:spPr>
      </p:pic>
      <p:sp>
        <p:nvSpPr>
          <p:cNvPr id="63" name="TextBox 62">
            <a:extLst>
              <a:ext uri="{FF2B5EF4-FFF2-40B4-BE49-F238E27FC236}">
                <a16:creationId xmlns:a16="http://schemas.microsoft.com/office/drawing/2014/main" id="{19C3C84D-6426-4CDD-A022-00F5578D7DC1}"/>
              </a:ext>
            </a:extLst>
          </p:cNvPr>
          <p:cNvSpPr txBox="1"/>
          <p:nvPr/>
        </p:nvSpPr>
        <p:spPr>
          <a:xfrm>
            <a:off x="3726644" y="9029146"/>
            <a:ext cx="2299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*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3FB24432-1B9D-4410-A595-19492E17A51C}"/>
              </a:ext>
            </a:extLst>
          </p:cNvPr>
          <p:cNvSpPr txBox="1"/>
          <p:nvPr/>
        </p:nvSpPr>
        <p:spPr>
          <a:xfrm>
            <a:off x="4561034" y="9040576"/>
            <a:ext cx="2299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*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3444B4DA-EDFD-4F8F-AB1A-D7382A424AE2}"/>
              </a:ext>
            </a:extLst>
          </p:cNvPr>
          <p:cNvSpPr txBox="1"/>
          <p:nvPr/>
        </p:nvSpPr>
        <p:spPr>
          <a:xfrm>
            <a:off x="5944877" y="8173885"/>
            <a:ext cx="2299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*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A94618C2-71A9-44E5-B54B-AB6F79BA5BBC}"/>
              </a:ext>
            </a:extLst>
          </p:cNvPr>
          <p:cNvSpPr txBox="1"/>
          <p:nvPr/>
        </p:nvSpPr>
        <p:spPr>
          <a:xfrm rot="16200000">
            <a:off x="4322648" y="8383257"/>
            <a:ext cx="12531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 dirty="0"/>
              <a:t> [U-</a:t>
            </a:r>
            <a:r>
              <a:rPr lang="en-US" sz="1200" b="1" baseline="30000" dirty="0"/>
              <a:t>13</a:t>
            </a:r>
            <a:r>
              <a:rPr lang="en-US" sz="1200" b="1" dirty="0"/>
              <a:t>C]-GLN</a:t>
            </a:r>
          </a:p>
          <a:p>
            <a:pPr algn="ctr"/>
            <a:r>
              <a:rPr lang="en-US" sz="1200" b="1" dirty="0"/>
              <a:t>(Acetoacetate)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9C4C62FC-B9E4-4CCB-9D60-09F6CD5289BE}"/>
              </a:ext>
            </a:extLst>
          </p:cNvPr>
          <p:cNvSpPr txBox="1"/>
          <p:nvPr/>
        </p:nvSpPr>
        <p:spPr>
          <a:xfrm>
            <a:off x="4823544" y="7713925"/>
            <a:ext cx="2343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27139B27-C37E-4CFD-AFCA-A0C44B1AF4F6}"/>
              </a:ext>
            </a:extLst>
          </p:cNvPr>
          <p:cNvSpPr txBox="1"/>
          <p:nvPr/>
        </p:nvSpPr>
        <p:spPr>
          <a:xfrm rot="16200000">
            <a:off x="-390814" y="8517746"/>
            <a:ext cx="13529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/>
              <a:t> </a:t>
            </a:r>
          </a:p>
          <a:p>
            <a:pPr algn="ctr"/>
            <a:r>
              <a:rPr lang="en-US" sz="1000" b="1" dirty="0"/>
              <a:t>Norm. Rel abundance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2B3924C7-2659-4858-AE58-665ACB3DF29E}"/>
              </a:ext>
            </a:extLst>
          </p:cNvPr>
          <p:cNvSpPr txBox="1"/>
          <p:nvPr/>
        </p:nvSpPr>
        <p:spPr>
          <a:xfrm>
            <a:off x="1328875" y="8087316"/>
            <a:ext cx="2299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*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6CA69A57-E5F9-450B-AE4A-3BB712ED57FB}"/>
              </a:ext>
            </a:extLst>
          </p:cNvPr>
          <p:cNvSpPr txBox="1"/>
          <p:nvPr/>
        </p:nvSpPr>
        <p:spPr>
          <a:xfrm>
            <a:off x="1739672" y="8375339"/>
            <a:ext cx="2299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*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4627BD18-C84C-4713-ACB7-98F4AECF82D0}"/>
              </a:ext>
            </a:extLst>
          </p:cNvPr>
          <p:cNvSpPr txBox="1"/>
          <p:nvPr/>
        </p:nvSpPr>
        <p:spPr>
          <a:xfrm>
            <a:off x="2210957" y="8327550"/>
            <a:ext cx="2299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/>
              <a:t>*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7B0DD02F-0035-4B60-9B07-0D77A6980106}"/>
              </a:ext>
            </a:extLst>
          </p:cNvPr>
          <p:cNvSpPr txBox="1"/>
          <p:nvPr/>
        </p:nvSpPr>
        <p:spPr>
          <a:xfrm>
            <a:off x="5882071" y="5840702"/>
            <a:ext cx="2299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*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7A35EBDC-F89A-49D5-B7F3-18689C07D2E1}"/>
              </a:ext>
            </a:extLst>
          </p:cNvPr>
          <p:cNvSpPr txBox="1"/>
          <p:nvPr/>
        </p:nvSpPr>
        <p:spPr>
          <a:xfrm>
            <a:off x="6670741" y="5852132"/>
            <a:ext cx="2299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28726003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7EF9D744-6138-43BD-8673-6F9D42B149E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1194" b="3413"/>
          <a:stretch/>
        </p:blipFill>
        <p:spPr>
          <a:xfrm rot="5400000">
            <a:off x="2769093" y="120286"/>
            <a:ext cx="1777013" cy="4473268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7294BF8-307E-43D8-AE51-3E7788B40B54}"/>
              </a:ext>
            </a:extLst>
          </p:cNvPr>
          <p:cNvSpPr txBox="1"/>
          <p:nvPr/>
        </p:nvSpPr>
        <p:spPr>
          <a:xfrm rot="5400000">
            <a:off x="5745743" y="1634183"/>
            <a:ext cx="5469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Hi-Fat</a:t>
            </a:r>
          </a:p>
        </p:txBody>
      </p:sp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FAC530C6-F9A5-4F2E-83BF-768D5821DF4F}"/>
              </a:ext>
            </a:extLst>
          </p:cNvPr>
          <p:cNvCxnSpPr>
            <a:cxnSpLocks/>
          </p:cNvCxnSpPr>
          <p:nvPr/>
        </p:nvCxnSpPr>
        <p:spPr>
          <a:xfrm>
            <a:off x="5946071" y="1944077"/>
            <a:ext cx="0" cy="25334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6EA4B983-56E7-4230-9012-7F15538EA4DA}"/>
              </a:ext>
            </a:extLst>
          </p:cNvPr>
          <p:cNvCxnSpPr>
            <a:cxnSpLocks/>
          </p:cNvCxnSpPr>
          <p:nvPr/>
        </p:nvCxnSpPr>
        <p:spPr>
          <a:xfrm>
            <a:off x="5946071" y="1569803"/>
            <a:ext cx="0" cy="253347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50CD11B6-83C8-4870-B7D2-A9EFFB321601}"/>
              </a:ext>
            </a:extLst>
          </p:cNvPr>
          <p:cNvSpPr txBox="1"/>
          <p:nvPr/>
        </p:nvSpPr>
        <p:spPr>
          <a:xfrm rot="5400000">
            <a:off x="5834256" y="1963028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Reg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5707357-FB98-46E3-A43B-38DCC7E51163}"/>
              </a:ext>
            </a:extLst>
          </p:cNvPr>
          <p:cNvSpPr txBox="1"/>
          <p:nvPr/>
        </p:nvSpPr>
        <p:spPr>
          <a:xfrm>
            <a:off x="3215190" y="1071650"/>
            <a:ext cx="9092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UCSD354L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42CCCC2-D492-4912-9EDC-90699AE35BE5}"/>
              </a:ext>
            </a:extLst>
          </p:cNvPr>
          <p:cNvSpPr txBox="1"/>
          <p:nvPr/>
        </p:nvSpPr>
        <p:spPr>
          <a:xfrm>
            <a:off x="1049773" y="102275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FA86B9C-DCAD-45CE-87A9-ED2C7868DB0C}"/>
              </a:ext>
            </a:extLst>
          </p:cNvPr>
          <p:cNvSpPr txBox="1"/>
          <p:nvPr/>
        </p:nvSpPr>
        <p:spPr>
          <a:xfrm>
            <a:off x="5882033" y="71605"/>
            <a:ext cx="135325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9D31F7A3-5B97-4790-A137-0AF48E754C2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102" t="2194" r="1199" b="2207"/>
          <a:stretch/>
        </p:blipFill>
        <p:spPr>
          <a:xfrm>
            <a:off x="537943" y="6966741"/>
            <a:ext cx="2733675" cy="2135792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4E065E90-3FE2-42A7-AB5C-5FB0175CF48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200" t="1619" r="1344" b="2082"/>
          <a:stretch/>
        </p:blipFill>
        <p:spPr>
          <a:xfrm>
            <a:off x="4021376" y="6964782"/>
            <a:ext cx="2693749" cy="2133833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C91F341E-688E-423F-8EB0-17A5554A27E3}"/>
              </a:ext>
            </a:extLst>
          </p:cNvPr>
          <p:cNvSpPr txBox="1"/>
          <p:nvPr/>
        </p:nvSpPr>
        <p:spPr>
          <a:xfrm>
            <a:off x="3752757" y="669097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7AEFECC-A54A-48EC-923F-47507FBDD6D1}"/>
              </a:ext>
            </a:extLst>
          </p:cNvPr>
          <p:cNvSpPr txBox="1"/>
          <p:nvPr/>
        </p:nvSpPr>
        <p:spPr>
          <a:xfrm>
            <a:off x="255036" y="669097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45AEC66-1528-4BD1-9274-232BE9A09008}"/>
              </a:ext>
            </a:extLst>
          </p:cNvPr>
          <p:cNvSpPr txBox="1"/>
          <p:nvPr/>
        </p:nvSpPr>
        <p:spPr>
          <a:xfrm rot="16200000">
            <a:off x="-474489" y="7859990"/>
            <a:ext cx="18069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%  Change in Body Weight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DF86A30-FE20-4425-B8B7-EA8F1C255868}"/>
              </a:ext>
            </a:extLst>
          </p:cNvPr>
          <p:cNvSpPr txBox="1"/>
          <p:nvPr/>
        </p:nvSpPr>
        <p:spPr>
          <a:xfrm rot="16200000">
            <a:off x="3017408" y="7859990"/>
            <a:ext cx="18069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%  Change in Body Weight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BD564AB-A231-435F-ADD0-82D68788DD13}"/>
              </a:ext>
            </a:extLst>
          </p:cNvPr>
          <p:cNvSpPr txBox="1"/>
          <p:nvPr/>
        </p:nvSpPr>
        <p:spPr>
          <a:xfrm>
            <a:off x="1845984" y="9132081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52ED13B-9E51-44C7-9EB5-BC9E9D960CAD}"/>
              </a:ext>
            </a:extLst>
          </p:cNvPr>
          <p:cNvSpPr txBox="1"/>
          <p:nvPr/>
        </p:nvSpPr>
        <p:spPr>
          <a:xfrm>
            <a:off x="5281433" y="9132082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CCD705C-94B6-4A94-A009-1F9B553FAE96}"/>
              </a:ext>
            </a:extLst>
          </p:cNvPr>
          <p:cNvSpPr txBox="1"/>
          <p:nvPr/>
        </p:nvSpPr>
        <p:spPr>
          <a:xfrm rot="5400000">
            <a:off x="817914" y="1755333"/>
            <a:ext cx="10309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-4.11        3.63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056FFAF-C56B-43D1-B25D-AC5E331DDB3D}"/>
              </a:ext>
            </a:extLst>
          </p:cNvPr>
          <p:cNvSpPr txBox="1"/>
          <p:nvPr/>
        </p:nvSpPr>
        <p:spPr>
          <a:xfrm>
            <a:off x="1712133" y="6714054"/>
            <a:ext cx="7569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Reg Diet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CC855242-2DB8-40CA-8A4B-24A8C0EF70B6}"/>
              </a:ext>
            </a:extLst>
          </p:cNvPr>
          <p:cNvSpPr txBox="1"/>
          <p:nvPr/>
        </p:nvSpPr>
        <p:spPr>
          <a:xfrm>
            <a:off x="5047897" y="6714054"/>
            <a:ext cx="135005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High-fat keto Diet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727A494-7AA5-403F-82BF-CBC42C03A8E9}"/>
              </a:ext>
            </a:extLst>
          </p:cNvPr>
          <p:cNvSpPr txBox="1"/>
          <p:nvPr/>
        </p:nvSpPr>
        <p:spPr>
          <a:xfrm>
            <a:off x="1049773" y="364727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6A9C1E3C-FEF9-4DC8-B9DC-B9EFAFE43313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965" t="1903" r="1503" b="2933"/>
          <a:stretch/>
        </p:blipFill>
        <p:spPr>
          <a:xfrm>
            <a:off x="2090602" y="3955047"/>
            <a:ext cx="2733675" cy="2346018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D968EC6D-339E-4430-8ED6-94CF3CDE364F}"/>
              </a:ext>
            </a:extLst>
          </p:cNvPr>
          <p:cNvSpPr txBox="1"/>
          <p:nvPr/>
        </p:nvSpPr>
        <p:spPr>
          <a:xfrm>
            <a:off x="3261232" y="3647270"/>
            <a:ext cx="5677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A375</a:t>
            </a:r>
          </a:p>
        </p:txBody>
      </p:sp>
      <p:sp>
        <p:nvSpPr>
          <p:cNvPr id="25" name="Right Bracket 24">
            <a:extLst>
              <a:ext uri="{FF2B5EF4-FFF2-40B4-BE49-F238E27FC236}">
                <a16:creationId xmlns:a16="http://schemas.microsoft.com/office/drawing/2014/main" id="{D30DAE2F-01EF-4E6F-BFC7-00362566EAAA}"/>
              </a:ext>
            </a:extLst>
          </p:cNvPr>
          <p:cNvSpPr/>
          <p:nvPr/>
        </p:nvSpPr>
        <p:spPr>
          <a:xfrm>
            <a:off x="4748154" y="4532588"/>
            <a:ext cx="45719" cy="782353"/>
          </a:xfrm>
          <a:prstGeom prst="rightBracket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1B49C74-6180-45AC-A9D4-244476D47BF9}"/>
              </a:ext>
            </a:extLst>
          </p:cNvPr>
          <p:cNvSpPr txBox="1"/>
          <p:nvPr/>
        </p:nvSpPr>
        <p:spPr>
          <a:xfrm>
            <a:off x="4730711" y="4769875"/>
            <a:ext cx="1841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*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F46ABD5-64A5-4DB7-B567-EAF4EA184E72}"/>
              </a:ext>
            </a:extLst>
          </p:cNvPr>
          <p:cNvSpPr txBox="1"/>
          <p:nvPr/>
        </p:nvSpPr>
        <p:spPr>
          <a:xfrm rot="16200000">
            <a:off x="1278807" y="4906160"/>
            <a:ext cx="14782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umor Volume (mm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970AED7-2978-4B7A-8CF4-1BB87723712D}"/>
              </a:ext>
            </a:extLst>
          </p:cNvPr>
          <p:cNvSpPr txBox="1"/>
          <p:nvPr/>
        </p:nvSpPr>
        <p:spPr>
          <a:xfrm>
            <a:off x="3323454" y="6218405"/>
            <a:ext cx="4892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ays</a:t>
            </a:r>
          </a:p>
        </p:txBody>
      </p:sp>
    </p:spTree>
    <p:extLst>
      <p:ext uri="{BB962C8B-B14F-4D97-AF65-F5344CB8AC3E}">
        <p14:creationId xmlns:p14="http://schemas.microsoft.com/office/powerpoint/2010/main" val="11752185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04</TotalTime>
  <Words>180</Words>
  <Application>Microsoft Office PowerPoint</Application>
  <PresentationFormat>Custom</PresentationFormat>
  <Paragraphs>10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ennu Nanda,Vashisht Gopal</dc:creator>
  <cp:lastModifiedBy>Yennu Nanda,Vashisht Gopal</cp:lastModifiedBy>
  <cp:revision>51</cp:revision>
  <dcterms:created xsi:type="dcterms:W3CDTF">2021-06-29T03:15:12Z</dcterms:created>
  <dcterms:modified xsi:type="dcterms:W3CDTF">2021-12-02T20:55:28Z</dcterms:modified>
</cp:coreProperties>
</file>